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56" r:id="rId4"/>
    <p:sldId id="263" r:id="rId5"/>
    <p:sldId id="264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48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432" y="84"/>
      </p:cViewPr>
      <p:guideLst>
        <p:guide orient="horz" pos="4248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059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123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29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62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764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9468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524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107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193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641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95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E6729-B534-49EE-88B9-F274189D364F}" type="datetimeFigureOut">
              <a:rPr lang="en-US" smtClean="0"/>
              <a:t>9/1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EEDD6-E5FB-4C5B-9C5E-6A25FE448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81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1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20.png"/><Relationship Id="rId10" Type="http://schemas.openxmlformats.org/officeDocument/2006/relationships/image" Target="../media/image37.png"/><Relationship Id="rId4" Type="http://schemas.openxmlformats.org/officeDocument/2006/relationships/image" Target="../media/image32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05" t="27853" r="34843" b="43762"/>
          <a:stretch/>
        </p:blipFill>
        <p:spPr>
          <a:xfrm>
            <a:off x="6768052" y="985651"/>
            <a:ext cx="1460665" cy="147254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108149" y="431653"/>
            <a:ext cx="780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A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1424062" y="6488668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1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83304" y="61631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6270" y="616319"/>
            <a:ext cx="5158716" cy="2493174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3415477" y="431653"/>
            <a:ext cx="1567543" cy="94588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251635" y="1997217"/>
            <a:ext cx="1567543" cy="94588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5894986" y="2470159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863550" y="1830825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F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852004" y="580049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3059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33713" y="4390102"/>
            <a:ext cx="1482683" cy="23922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flipH="1">
            <a:off x="9429651" y="2482997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K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 flipH="1">
            <a:off x="11294428" y="5572434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 flipH="1">
            <a:off x="11382694" y="6488668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2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l="19617" r="4325"/>
          <a:stretch/>
        </p:blipFill>
        <p:spPr>
          <a:xfrm>
            <a:off x="9833714" y="2638855"/>
            <a:ext cx="1460714" cy="175124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 flipH="1">
            <a:off x="11237830" y="3367887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5688" y="589498"/>
            <a:ext cx="3573955" cy="237218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flipH="1">
            <a:off x="373326" y="228247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 flipH="1">
            <a:off x="4166899" y="1775591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906555" y="1876301"/>
            <a:ext cx="1567543" cy="4688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3148" y="2673840"/>
            <a:ext cx="3541900" cy="1362782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922766" y="3338620"/>
            <a:ext cx="1567543" cy="69800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 flipH="1">
            <a:off x="4183110" y="3338620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/>
          <a:srcRect l="14878" t="-2622" r="22837" b="7097"/>
          <a:stretch/>
        </p:blipFill>
        <p:spPr>
          <a:xfrm>
            <a:off x="906554" y="4117728"/>
            <a:ext cx="1567543" cy="1156013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flipH="1">
            <a:off x="2592665" y="4273137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LVRA</a:t>
            </a:r>
            <a:endParaRPr lang="en-US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7"/>
          <a:srcRect r="43681"/>
          <a:stretch/>
        </p:blipFill>
        <p:spPr>
          <a:xfrm>
            <a:off x="5428326" y="711988"/>
            <a:ext cx="1496674" cy="1633161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854299" y="711988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 flipH="1">
            <a:off x="5443631" y="131126"/>
            <a:ext cx="864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E</a:t>
            </a:r>
            <a:endParaRPr lang="en-US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/>
          <a:srcRect l="64679" r="9801"/>
          <a:stretch/>
        </p:blipFill>
        <p:spPr>
          <a:xfrm>
            <a:off x="5412102" y="2595796"/>
            <a:ext cx="747243" cy="1511146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412102" y="2482997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9"/>
          <a:srcRect l="54142"/>
          <a:stretch/>
        </p:blipFill>
        <p:spPr>
          <a:xfrm>
            <a:off x="7627523" y="3036995"/>
            <a:ext cx="1088185" cy="1209415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7674658" y="2638855"/>
            <a:ext cx="780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A</a:t>
            </a:r>
            <a:endParaRPr lang="en-US" dirty="0"/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956183" y="680667"/>
            <a:ext cx="1125344" cy="1703599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7091962" y="655922"/>
            <a:ext cx="777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</a:t>
            </a:r>
            <a:r>
              <a:rPr lang="en-US" b="1" dirty="0" smtClean="0"/>
              <a:t>B</a:t>
            </a:r>
            <a:endParaRPr lang="en-US" dirty="0"/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11"/>
          <a:srcRect b="18757"/>
          <a:stretch/>
        </p:blipFill>
        <p:spPr>
          <a:xfrm>
            <a:off x="6195166" y="2990177"/>
            <a:ext cx="1376669" cy="1106219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6131129" y="2667663"/>
            <a:ext cx="777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</a:t>
            </a:r>
            <a:r>
              <a:rPr lang="en-US" b="1" dirty="0" smtClean="0"/>
              <a:t>B</a:t>
            </a:r>
            <a:endParaRPr lang="en-US" dirty="0"/>
          </a:p>
        </p:txBody>
      </p:sp>
      <p:sp>
        <p:nvSpPr>
          <p:cNvPr id="28" name="Rectangle 27"/>
          <p:cNvSpPr/>
          <p:nvPr/>
        </p:nvSpPr>
        <p:spPr>
          <a:xfrm>
            <a:off x="7518855" y="3648880"/>
            <a:ext cx="1196853" cy="4688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12"/>
          <a:srcRect l="-724" t="37982" r="724" b="-4916"/>
          <a:stretch/>
        </p:blipFill>
        <p:spPr>
          <a:xfrm>
            <a:off x="8107421" y="694357"/>
            <a:ext cx="1301423" cy="1668422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8434082" y="496001"/>
            <a:ext cx="7868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</a:t>
            </a:r>
            <a:r>
              <a:rPr lang="en-US" b="1" dirty="0"/>
              <a:t>A</a:t>
            </a:r>
            <a:endParaRPr lang="en-US" dirty="0"/>
          </a:p>
        </p:txBody>
      </p:sp>
      <p:sp>
        <p:nvSpPr>
          <p:cNvPr id="31" name="Rectangle 30"/>
          <p:cNvSpPr/>
          <p:nvPr/>
        </p:nvSpPr>
        <p:spPr>
          <a:xfrm>
            <a:off x="7990148" y="1434217"/>
            <a:ext cx="1567543" cy="46884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282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667" y="228416"/>
            <a:ext cx="5499699" cy="308307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239820" y="232061"/>
            <a:ext cx="1567543" cy="298961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0" y="2126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744300" y="700643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ERK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744300" y="1542202"/>
            <a:ext cx="486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IP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759682" y="2551214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OP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6838657" y="4084922"/>
            <a:ext cx="4794543" cy="1804218"/>
          </a:xfrm>
          <a:prstGeom prst="rect">
            <a:avLst/>
          </a:prstGeom>
        </p:spPr>
      </p:pic>
      <p:sp>
        <p:nvSpPr>
          <p:cNvPr id="27" name="Rectangle 26"/>
          <p:cNvSpPr/>
          <p:nvPr/>
        </p:nvSpPr>
        <p:spPr>
          <a:xfrm>
            <a:off x="9922933" y="4325452"/>
            <a:ext cx="1434396" cy="33710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11386535" y="4293227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P90</a:t>
            </a:r>
            <a:endParaRPr lang="en-US" dirty="0"/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83937" y="580466"/>
            <a:ext cx="4219057" cy="61226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1227850" y="668520"/>
            <a:ext cx="7804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A</a:t>
            </a:r>
            <a:endParaRPr lang="en-US" dirty="0"/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/>
          <a:srcRect l="-201" t="21916" r="1332" b="4162"/>
          <a:stretch/>
        </p:blipFill>
        <p:spPr>
          <a:xfrm>
            <a:off x="7078453" y="1242355"/>
            <a:ext cx="4219057" cy="1810448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11185616" y="1684951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6"/>
          <a:srcRect l="3418" t="8742" r="2986" b="9851"/>
          <a:stretch/>
        </p:blipFill>
        <p:spPr>
          <a:xfrm>
            <a:off x="6799286" y="3102428"/>
            <a:ext cx="4403708" cy="1199599"/>
          </a:xfrm>
          <a:prstGeom prst="rect">
            <a:avLst/>
          </a:prstGeom>
        </p:spPr>
      </p:pic>
      <p:sp>
        <p:nvSpPr>
          <p:cNvPr id="44" name="Rectangle 43"/>
          <p:cNvSpPr/>
          <p:nvPr/>
        </p:nvSpPr>
        <p:spPr>
          <a:xfrm>
            <a:off x="9715629" y="539659"/>
            <a:ext cx="1557994" cy="351071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11227850" y="3126067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46" name="TextBox 45"/>
          <p:cNvSpPr txBox="1"/>
          <p:nvPr/>
        </p:nvSpPr>
        <p:spPr>
          <a:xfrm>
            <a:off x="11329060" y="6323789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8478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329060" y="6323789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5805" t="11255" r="1808" b="24646"/>
          <a:stretch/>
        </p:blipFill>
        <p:spPr>
          <a:xfrm>
            <a:off x="458856" y="329699"/>
            <a:ext cx="4102445" cy="131695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618635" y="496023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OP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9631543" y="730468"/>
            <a:ext cx="663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P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V="1">
            <a:off x="608859" y="3109799"/>
            <a:ext cx="3856049" cy="187675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49705" y="3863512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t="23647" b="21705"/>
          <a:stretch/>
        </p:blipFill>
        <p:spPr>
          <a:xfrm flipV="1">
            <a:off x="6096000" y="1646650"/>
            <a:ext cx="3759196" cy="99985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6206196" y="438470"/>
            <a:ext cx="3425347" cy="1129281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8001074" y="730468"/>
            <a:ext cx="1598111" cy="191603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9856427" y="196191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4145" y="1706913"/>
            <a:ext cx="4134490" cy="139994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618635" y="2543634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99159" y="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834406" y="36113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/>
          <a:srcRect b="9381"/>
          <a:stretch/>
        </p:blipFill>
        <p:spPr>
          <a:xfrm>
            <a:off x="9167483" y="3097048"/>
            <a:ext cx="1950804" cy="3493757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>
            <a:off x="9450130" y="4351704"/>
            <a:ext cx="1567543" cy="92429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9938788" y="2748292"/>
            <a:ext cx="5902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NE</a:t>
            </a:r>
            <a:endParaRPr lang="en-US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15184" y="3097048"/>
            <a:ext cx="1495104" cy="3449231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8001074" y="2727716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QO1</a:t>
            </a:r>
            <a:endParaRPr lang="en-US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46369" y="3242333"/>
            <a:ext cx="1398185" cy="2698136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6498077" y="2828402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5988542" y="2783802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8048422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43681"/>
          <a:stretch/>
        </p:blipFill>
        <p:spPr>
          <a:xfrm>
            <a:off x="2401522" y="1437815"/>
            <a:ext cx="2241730" cy="244616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7388" y="2930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412800" y="816091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HER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200023" y="816091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/>
          <a:srcRect r="3753" b="46968"/>
          <a:stretch/>
        </p:blipFill>
        <p:spPr>
          <a:xfrm>
            <a:off x="4741497" y="1437815"/>
            <a:ext cx="2147634" cy="243354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1" t="21726" r="6042" b="9665"/>
          <a:stretch/>
        </p:blipFill>
        <p:spPr>
          <a:xfrm>
            <a:off x="7015958" y="1437816"/>
            <a:ext cx="1628440" cy="244541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134099" y="81609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402599" y="816091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t="30371"/>
          <a:stretch/>
        </p:blipFill>
        <p:spPr>
          <a:xfrm>
            <a:off x="386837" y="1471758"/>
            <a:ext cx="1894132" cy="247237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1329060" y="6323789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6</a:t>
            </a:r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/>
          <a:srcRect l="13618" r="43051" b="50067"/>
          <a:stretch/>
        </p:blipFill>
        <p:spPr>
          <a:xfrm flipV="1">
            <a:off x="1227332" y="4974267"/>
            <a:ext cx="1216057" cy="102618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17805" y="469333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443389" y="5302696"/>
            <a:ext cx="641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2</a:t>
            </a:r>
            <a:endParaRPr lang="en-US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9446" y="4793826"/>
            <a:ext cx="1082051" cy="1405372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741497" y="5417389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931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2162" t="21185" r="5318"/>
          <a:stretch/>
        </p:blipFill>
        <p:spPr>
          <a:xfrm>
            <a:off x="271820" y="4000460"/>
            <a:ext cx="2616179" cy="130981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306432" y="6289590"/>
            <a:ext cx="627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6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71820" y="335733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005571" y="4249449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2</a:t>
            </a:r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57537" y="3841769"/>
            <a:ext cx="1511603" cy="2151257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7047802" y="3559820"/>
            <a:ext cx="1006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PanP</a:t>
            </a:r>
            <a:r>
              <a:rPr lang="en-US" dirty="0" smtClean="0"/>
              <a:t>-Tyr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654426" y="3474730"/>
            <a:ext cx="2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4"/>
          <a:srcRect t="3510" r="55851" b="11141"/>
          <a:stretch/>
        </p:blipFill>
        <p:spPr>
          <a:xfrm>
            <a:off x="6883779" y="618906"/>
            <a:ext cx="879863" cy="232307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6938552" y="291095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D71</a:t>
            </a:r>
            <a:endParaRPr lang="en-US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5"/>
          <a:srcRect t="23647" b="21705"/>
          <a:stretch/>
        </p:blipFill>
        <p:spPr>
          <a:xfrm flipV="1">
            <a:off x="330983" y="4759054"/>
            <a:ext cx="2705244" cy="719527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1678665" y="4109176"/>
            <a:ext cx="1268498" cy="1916034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2949192" y="4997613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6086259" y="193287"/>
            <a:ext cx="656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EA1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2960153" y="261648"/>
            <a:ext cx="750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sc70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/>
          <a:srcRect l="31640"/>
          <a:stretch/>
        </p:blipFill>
        <p:spPr>
          <a:xfrm>
            <a:off x="6091954" y="527177"/>
            <a:ext cx="635226" cy="253795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49240" y="667073"/>
            <a:ext cx="1036823" cy="2226735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3867748" y="269348"/>
            <a:ext cx="923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athrin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66856" y="702470"/>
            <a:ext cx="836286" cy="2231718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4979698" y="291095"/>
            <a:ext cx="9816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aveolin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71349" y="562619"/>
            <a:ext cx="699592" cy="234731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0"/>
          <a:srcRect b="18860"/>
          <a:stretch/>
        </p:blipFill>
        <p:spPr>
          <a:xfrm>
            <a:off x="2190999" y="638681"/>
            <a:ext cx="715061" cy="230953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19558" y="690747"/>
            <a:ext cx="1046095" cy="2236028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2141857" y="261648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1107943" y="298426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AB7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568696" y="32141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2"/>
          <a:srcRect r="17222"/>
          <a:stretch/>
        </p:blipFill>
        <p:spPr>
          <a:xfrm>
            <a:off x="8505100" y="3839532"/>
            <a:ext cx="1577051" cy="215349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8749933" y="3470200"/>
            <a:ext cx="7724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LVRB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3"/>
          <a:srcRect t="2994"/>
          <a:stretch/>
        </p:blipFill>
        <p:spPr>
          <a:xfrm>
            <a:off x="10112940" y="3811978"/>
            <a:ext cx="1199726" cy="2186345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10326575" y="3463663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ct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8266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</TotalTime>
  <Words>70</Words>
  <Application>Microsoft Office PowerPoint</Application>
  <PresentationFormat>Widescreen</PresentationFormat>
  <Paragraphs>6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lia</dc:creator>
  <cp:lastModifiedBy>Marchenko, Natalia</cp:lastModifiedBy>
  <cp:revision>42</cp:revision>
  <dcterms:created xsi:type="dcterms:W3CDTF">2025-09-17T14:40:16Z</dcterms:created>
  <dcterms:modified xsi:type="dcterms:W3CDTF">2025-09-19T15:18:42Z</dcterms:modified>
</cp:coreProperties>
</file>